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5" r:id="rId3"/>
    <p:sldId id="266" r:id="rId4"/>
    <p:sldId id="267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60" d="100"/>
          <a:sy n="160" d="100"/>
        </p:scale>
        <p:origin x="114" y="-39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8540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21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580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3217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0328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220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293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9393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6333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6078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8878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2DF03-C2BB-4FF0-A87C-325F10EEC02F}" type="datetimeFigureOut">
              <a:rPr lang="zh-CN" altLang="en-US" smtClean="0"/>
              <a:t>2020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4B933-6144-4B6F-8F38-47CFF1DC3F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060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"/><Relationship Id="rId3" Type="http://schemas.openxmlformats.org/officeDocument/2006/relationships/image" Target="../media/image3.tif"/><Relationship Id="rId7" Type="http://schemas.openxmlformats.org/officeDocument/2006/relationships/image" Target="../media/image7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"/><Relationship Id="rId5" Type="http://schemas.openxmlformats.org/officeDocument/2006/relationships/image" Target="../media/image5.tif"/><Relationship Id="rId4" Type="http://schemas.openxmlformats.org/officeDocument/2006/relationships/image" Target="../media/image4.tif"/><Relationship Id="rId9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EC0D7E05-E98C-401A-A50E-8E1B50FD5E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2033958"/>
              </p:ext>
            </p:extLst>
          </p:nvPr>
        </p:nvGraphicFramePr>
        <p:xfrm>
          <a:off x="600075" y="1185866"/>
          <a:ext cx="3482827" cy="2751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8" name="Prism 7" r:id="rId3" imgW="3485033" imgH="2753378" progId="Prism7.Document">
                  <p:embed/>
                </p:oleObj>
              </mc:Choice>
              <mc:Fallback>
                <p:oleObj name="Prism 7" r:id="rId3" imgW="3485033" imgH="2753378" progId="Prism7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498AB37F-DCAC-4807-AAAC-32DE2E6591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0075" y="1185866"/>
                        <a:ext cx="3482827" cy="2751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375F6728-7899-4CE9-8D8C-F3A0CCF8C1A7}"/>
              </a:ext>
            </a:extLst>
          </p:cNvPr>
          <p:cNvSpPr txBox="1"/>
          <p:nvPr/>
        </p:nvSpPr>
        <p:spPr>
          <a:xfrm>
            <a:off x="566738" y="762003"/>
            <a:ext cx="2076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8283D84-A990-4ADE-8D30-23C4AEAB8466}"/>
              </a:ext>
            </a:extLst>
          </p:cNvPr>
          <p:cNvSpPr txBox="1"/>
          <p:nvPr/>
        </p:nvSpPr>
        <p:spPr>
          <a:xfrm>
            <a:off x="342898" y="4084451"/>
            <a:ext cx="6376878" cy="6170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2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 |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aily gametocytemia after day 6 post gametocyte induction. Results are the mean of three biological replicates (10000 RBCs counted per sample). All error bars indicate SD.</a:t>
            </a:r>
            <a:endParaRPr lang="zh-CN" altLang="zh-CN" sz="1200" kern="10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0125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7D6F87C-F539-4315-8B8F-B6E3A5C0A893}"/>
              </a:ext>
            </a:extLst>
          </p:cNvPr>
          <p:cNvSpPr txBox="1"/>
          <p:nvPr/>
        </p:nvSpPr>
        <p:spPr>
          <a:xfrm>
            <a:off x="897786" y="366275"/>
            <a:ext cx="2076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1FCA7C53-9C47-466E-BD2A-FE30A836F4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8410" y="1244223"/>
            <a:ext cx="1206683" cy="1038425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7B0B55B9-5DFB-4DFD-91BD-AE3B13769491}"/>
              </a:ext>
            </a:extLst>
          </p:cNvPr>
          <p:cNvSpPr txBox="1"/>
          <p:nvPr/>
        </p:nvSpPr>
        <p:spPr>
          <a:xfrm>
            <a:off x="890989" y="956524"/>
            <a:ext cx="603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F4281F9A-3C8A-4B75-8993-C5EF1CB615C0}"/>
              </a:ext>
            </a:extLst>
          </p:cNvPr>
          <p:cNvSpPr txBox="1"/>
          <p:nvPr/>
        </p:nvSpPr>
        <p:spPr>
          <a:xfrm>
            <a:off x="3354190" y="927196"/>
            <a:ext cx="84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A379C21-8342-476A-9BA8-0C4AC109F016}"/>
              </a:ext>
            </a:extLst>
          </p:cNvPr>
          <p:cNvSpPr txBox="1"/>
          <p:nvPr/>
        </p:nvSpPr>
        <p:spPr>
          <a:xfrm>
            <a:off x="4798465" y="927197"/>
            <a:ext cx="5191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IC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EC88DE2D-8F68-40FC-9F4E-4108DA90C923}"/>
              </a:ext>
            </a:extLst>
          </p:cNvPr>
          <p:cNvSpPr txBox="1"/>
          <p:nvPr/>
        </p:nvSpPr>
        <p:spPr>
          <a:xfrm>
            <a:off x="1775446" y="790138"/>
            <a:ext cx="13234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nti-Pfs16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nti-α-tubulin II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6A88B3D2-DF7C-4761-AF67-FAD6CC1CA77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3476" y="1244080"/>
            <a:ext cx="1205483" cy="1041025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987180C9-0EB6-4FCC-9A40-A604692F33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886" y="1241624"/>
            <a:ext cx="1205482" cy="1041024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5C8F5A6E-631D-4A8D-8A02-1C29CA19581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1360" y="2394499"/>
            <a:ext cx="1202473" cy="1038425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C9C20521-95F8-496F-81CE-86847C32A0E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886" y="2394500"/>
            <a:ext cx="1205482" cy="1041024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84487839-18A8-43F6-A829-7F2D6ACFB6A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486" y="2394499"/>
            <a:ext cx="1202473" cy="1038425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C884EACB-C666-488E-99E6-EB1CAF5E349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09" t="40901" r="42842" b="39846"/>
          <a:stretch/>
        </p:blipFill>
        <p:spPr>
          <a:xfrm>
            <a:off x="4326529" y="1243907"/>
            <a:ext cx="1321393" cy="1038741"/>
          </a:xfrm>
          <a:prstGeom prst="rect">
            <a:avLst/>
          </a:prstGeom>
        </p:spPr>
      </p:pic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522B4424-FDB3-4DF3-A58D-13076E5AA045}"/>
              </a:ext>
            </a:extLst>
          </p:cNvPr>
          <p:cNvCxnSpPr>
            <a:cxnSpLocks/>
          </p:cNvCxnSpPr>
          <p:nvPr/>
        </p:nvCxnSpPr>
        <p:spPr>
          <a:xfrm>
            <a:off x="5001422" y="2184988"/>
            <a:ext cx="6324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87084A30-3F8D-4C86-AC7E-8B99E5177581}"/>
              </a:ext>
            </a:extLst>
          </p:cNvPr>
          <p:cNvSpPr txBox="1"/>
          <p:nvPr/>
        </p:nvSpPr>
        <p:spPr>
          <a:xfrm>
            <a:off x="5255182" y="1962493"/>
            <a:ext cx="6036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l-GR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4A0A7A5F-D5D1-438E-9351-778E302D166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266" t="65225" r="26361" b="15401"/>
          <a:stretch/>
        </p:blipFill>
        <p:spPr>
          <a:xfrm>
            <a:off x="4326529" y="2394499"/>
            <a:ext cx="1345899" cy="1038425"/>
          </a:xfrm>
          <a:prstGeom prst="rect">
            <a:avLst/>
          </a:prstGeom>
        </p:spPr>
      </p:pic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2BDE8E82-2E1B-4427-AE12-FF659989404D}"/>
              </a:ext>
            </a:extLst>
          </p:cNvPr>
          <p:cNvCxnSpPr>
            <a:cxnSpLocks/>
          </p:cNvCxnSpPr>
          <p:nvPr/>
        </p:nvCxnSpPr>
        <p:spPr>
          <a:xfrm>
            <a:off x="4984869" y="3330976"/>
            <a:ext cx="66542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E032373C-C7FE-4495-AACF-98A62B63D22E}"/>
              </a:ext>
            </a:extLst>
          </p:cNvPr>
          <p:cNvSpPr txBox="1"/>
          <p:nvPr/>
        </p:nvSpPr>
        <p:spPr>
          <a:xfrm>
            <a:off x="5237658" y="3084755"/>
            <a:ext cx="621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l-GR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0A73489-7EAD-432B-9D02-01BAE03344C0}"/>
              </a:ext>
            </a:extLst>
          </p:cNvPr>
          <p:cNvSpPr txBox="1"/>
          <p:nvPr/>
        </p:nvSpPr>
        <p:spPr>
          <a:xfrm>
            <a:off x="346886" y="3676134"/>
            <a:ext cx="6164227" cy="8940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2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2 |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ti-Pfs16 IFA identifying stage Ⅰ gametocytes is shown at the top panel. Strong fluorescence of anti-α-tubulin II IFA identifying stage Ⅰ male gametocytes is shown at the bottom panel. Scale bars, 5 μm. </a:t>
            </a:r>
            <a:endParaRPr lang="zh-CN" altLang="zh-CN" sz="1200" kern="10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712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F81FB112-6918-4CC9-9F29-8DB59DC54157}"/>
              </a:ext>
            </a:extLst>
          </p:cNvPr>
          <p:cNvSpPr txBox="1"/>
          <p:nvPr/>
        </p:nvSpPr>
        <p:spPr>
          <a:xfrm>
            <a:off x="897786" y="366275"/>
            <a:ext cx="2076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5EEBF03-14E3-4774-B206-7233C659B6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773" y="1098151"/>
            <a:ext cx="5572398" cy="391933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718B2F2-6047-427A-9470-C706FC7B325B}"/>
              </a:ext>
            </a:extLst>
          </p:cNvPr>
          <p:cNvSpPr txBox="1"/>
          <p:nvPr/>
        </p:nvSpPr>
        <p:spPr>
          <a:xfrm>
            <a:off x="277585" y="5170716"/>
            <a:ext cx="630282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3 | </a:t>
            </a:r>
            <a:r>
              <a:rPr lang="en-US" altLang="zh-CN" sz="120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HIP-qPCR analysis using primer pairs targeting to different upstream regions of genes down-regulated at ring stage. 500 and 1000 indicate that primers are located at about 500 bp and 1000 bp before the start codon of genes,</a:t>
            </a:r>
            <a:r>
              <a:rPr lang="en-US" altLang="zh-CN" sz="1200" i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20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spectively. </a:t>
            </a:r>
            <a:r>
              <a:rPr lang="en-US" altLang="zh-CN" sz="1200" i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f3D7_1139300</a:t>
            </a:r>
            <a:r>
              <a:rPr lang="en-US" altLang="zh-CN" sz="120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was used as a negative control. Primers for ChIP-qPCR are shown in Supplementary Table 1. The experiment was repeated twice. All error bars indicate SD. </a:t>
            </a:r>
            <a:endParaRPr lang="zh-CN" altLang="en-US" sz="1200"/>
          </a:p>
        </p:txBody>
      </p:sp>
    </p:spTree>
    <p:extLst>
      <p:ext uri="{BB962C8B-B14F-4D97-AF65-F5344CB8AC3E}">
        <p14:creationId xmlns:p14="http://schemas.microsoft.com/office/powerpoint/2010/main" val="38236458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9F2AAC10-BF3E-477A-A72F-98F3B6360990}"/>
              </a:ext>
            </a:extLst>
          </p:cNvPr>
          <p:cNvSpPr txBox="1"/>
          <p:nvPr/>
        </p:nvSpPr>
        <p:spPr>
          <a:xfrm>
            <a:off x="642938" y="598717"/>
            <a:ext cx="2076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863A384-C4F5-43DF-80FD-A5B68243FA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2511" y="1787217"/>
            <a:ext cx="2779776" cy="293522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9BA687F-A4EE-4932-9CDA-877FEA32BD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48" y="1787217"/>
            <a:ext cx="2816352" cy="2935224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6CA9C241-42B5-4E68-8C1B-8E3A5D19C307}"/>
              </a:ext>
            </a:extLst>
          </p:cNvPr>
          <p:cNvSpPr txBox="1"/>
          <p:nvPr/>
        </p:nvSpPr>
        <p:spPr>
          <a:xfrm>
            <a:off x="642938" y="1393961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649F93E-B8A4-41B8-A92B-D3E028927FD2}"/>
              </a:ext>
            </a:extLst>
          </p:cNvPr>
          <p:cNvSpPr txBox="1"/>
          <p:nvPr/>
        </p:nvSpPr>
        <p:spPr>
          <a:xfrm>
            <a:off x="3799114" y="1393961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1B81EAB-5E16-4B49-9B6C-D5ABAB9CDC5D}"/>
              </a:ext>
            </a:extLst>
          </p:cNvPr>
          <p:cNvSpPr txBox="1"/>
          <p:nvPr/>
        </p:nvSpPr>
        <p:spPr>
          <a:xfrm>
            <a:off x="446314" y="4722441"/>
            <a:ext cx="57990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4 | 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T-qPCR for validating the expression of PfAP2-G2 in </a:t>
            </a:r>
            <a:r>
              <a:rPr lang="en-US" altLang="zh-CN" sz="1200" i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fAP2-G2 (-)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arasites at ring and schizont stages. Primers are located at 44bp (A) and 4797bp (B) behind the start codon, respectively. </a:t>
            </a:r>
            <a:r>
              <a:rPr lang="en-US" altLang="zh-CN" sz="120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rimers for RT-qPCR are shown in Supplementary Table 1. The experiment was repeated three times. All error bars indicate SD.</a:t>
            </a:r>
            <a:endParaRPr lang="zh-CN" altLang="en-US" sz="1200"/>
          </a:p>
        </p:txBody>
      </p:sp>
    </p:spTree>
    <p:extLst>
      <p:ext uri="{BB962C8B-B14F-4D97-AF65-F5344CB8AC3E}">
        <p14:creationId xmlns:p14="http://schemas.microsoft.com/office/powerpoint/2010/main" val="2627869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70</TotalTime>
  <Words>241</Words>
  <Application>Microsoft Office PowerPoint</Application>
  <PresentationFormat>全屏显示(4:3)</PresentationFormat>
  <Paragraphs>17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1" baseType="lpstr">
      <vt:lpstr>等线</vt:lpstr>
      <vt:lpstr>Arial</vt:lpstr>
      <vt:lpstr>Calibri</vt:lpstr>
      <vt:lpstr>Calibri Light</vt:lpstr>
      <vt:lpstr>Times New Roman</vt:lpstr>
      <vt:lpstr>Office 主题​​</vt:lpstr>
      <vt:lpstr>Prism 7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瑶征 许</dc:creator>
  <cp:lastModifiedBy>瑶征 许</cp:lastModifiedBy>
  <cp:revision>94</cp:revision>
  <dcterms:created xsi:type="dcterms:W3CDTF">2020-08-21T08:23:00Z</dcterms:created>
  <dcterms:modified xsi:type="dcterms:W3CDTF">2020-11-17T02:08:26Z</dcterms:modified>
</cp:coreProperties>
</file>